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9" r:id="rId2"/>
    <p:sldId id="260" r:id="rId3"/>
  </p:sldIdLst>
  <p:sldSz cx="6859588" cy="8004175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22">
          <p15:clr>
            <a:srgbClr val="A4A3A4"/>
          </p15:clr>
        </p15:guide>
        <p15:guide id="2" pos="216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29" autoAdjust="0"/>
  </p:normalViewPr>
  <p:slideViewPr>
    <p:cSldViewPr>
      <p:cViewPr varScale="1">
        <p:scale>
          <a:sx n="82" d="100"/>
          <a:sy n="82" d="100"/>
        </p:scale>
        <p:origin x="2488" y="44"/>
      </p:cViewPr>
      <p:guideLst>
        <p:guide orient="horz" pos="2522"/>
        <p:guide pos="216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Johannes\Conidiation\ausz&#228;hlung%20conidiation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Johannes\Conidiation\ausz&#228;hlung%20conidiat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990208333333334"/>
          <c:y val="7.7611111111111117E-2"/>
          <c:w val="0.86009791666666668"/>
          <c:h val="0.8447777777777777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mob2 cbk1 in locus 14.7.16'!$I$42,'mob2 cbk1 in locus 14.7.16'!$I$46,'mob2 cbk1 in locus 14.7.16'!$I$50,'mob2 cbk1 in locus 14.7.16'!$I$54)</c:f>
                <c:numCache>
                  <c:formatCode>General</c:formatCode>
                  <c:ptCount val="4"/>
                  <c:pt idx="0">
                    <c:v>0.33507461855533022</c:v>
                  </c:pt>
                  <c:pt idx="1">
                    <c:v>0.3798683982644519</c:v>
                  </c:pt>
                  <c:pt idx="2">
                    <c:v>1.8471532150853103</c:v>
                  </c:pt>
                  <c:pt idx="3">
                    <c:v>0.655057249406493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 cap="flat">
                <a:miter lim="800000"/>
              </a:ln>
            </c:spPr>
          </c:errBars>
          <c:cat>
            <c:strRef>
              <c:f>('mob2 cbk1 in locus 14.7.16'!$C$5,'mob2 cbk1 in locus 14.7.16'!$C$9,'mob2 cbk1 in locus 14.7.16'!$C$13,'mob2 cbk1 in locus 14.7.16'!$C$17)</c:f>
              <c:strCache>
                <c:ptCount val="4"/>
                <c:pt idx="0">
                  <c:v>Δku80</c:v>
                </c:pt>
                <c:pt idx="1">
                  <c:v>CBK1-mCherry</c:v>
                </c:pt>
                <c:pt idx="2">
                  <c:v>MOB2-GFP</c:v>
                </c:pt>
                <c:pt idx="3">
                  <c:v>MOB2-GFP + CBK1-mCherry</c:v>
                </c:pt>
              </c:strCache>
            </c:strRef>
          </c:cat>
          <c:val>
            <c:numRef>
              <c:f>('mob2 cbk1 in locus 14.7.16'!$G$42,'mob2 cbk1 in locus 14.7.16'!$G$46,'mob2 cbk1 in locus 14.7.16'!$G$50,'mob2 cbk1 in locus 14.7.16'!$G$54)</c:f>
              <c:numCache>
                <c:formatCode>General</c:formatCode>
                <c:ptCount val="4"/>
                <c:pt idx="0">
                  <c:v>9.5250000000000004</c:v>
                </c:pt>
                <c:pt idx="1">
                  <c:v>8.5200000000000014</c:v>
                </c:pt>
                <c:pt idx="2">
                  <c:v>8.9849999999999994</c:v>
                </c:pt>
                <c:pt idx="3">
                  <c:v>8.5299999999999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233-48D2-91DF-37470E6B5D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6972288"/>
        <c:axId val="86973824"/>
      </c:barChart>
      <c:catAx>
        <c:axId val="8697228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86973824"/>
        <c:crosses val="autoZero"/>
        <c:auto val="1"/>
        <c:lblAlgn val="ctr"/>
        <c:lblOffset val="100"/>
        <c:noMultiLvlLbl val="0"/>
      </c:catAx>
      <c:valAx>
        <c:axId val="86973824"/>
        <c:scaling>
          <c:orientation val="minMax"/>
          <c:max val="11"/>
          <c:min val="0"/>
        </c:scaling>
        <c:delete val="0"/>
        <c:axPos val="l"/>
        <c:majorGridlines>
          <c:spPr>
            <a:ln w="12700">
              <a:solidFill>
                <a:schemeClr val="tx1"/>
              </a:solidFill>
            </a:ln>
          </c:spPr>
        </c:majorGridlines>
        <c:title>
          <c:tx>
            <c:rich>
              <a:bodyPr rot="-5400000" vert="horz"/>
              <a:lstStyle/>
              <a:p>
                <a:pPr algn="ctr" rtl="0">
                  <a:defRPr/>
                </a:pPr>
                <a:r>
                  <a:rPr lang="de-DE" dirty="0" err="1"/>
                  <a:t>conidia</a:t>
                </a:r>
                <a:r>
                  <a:rPr lang="de-DE" dirty="0"/>
                  <a:t> * 10</a:t>
                </a:r>
                <a:r>
                  <a:rPr lang="de-DE" baseline="30000" dirty="0"/>
                  <a:t>7 </a:t>
                </a:r>
                <a:r>
                  <a:rPr lang="de-DE" dirty="0"/>
                  <a:t>per </a:t>
                </a:r>
                <a:r>
                  <a:rPr lang="de-DE" dirty="0" err="1"/>
                  <a:t>well</a:t>
                </a:r>
                <a:endParaRPr lang="de-DE" dirty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8697228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078402777777776"/>
          <c:y val="7.7611111111111117E-2"/>
          <c:w val="0.85921597222222224"/>
          <c:h val="0.8447777777777777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mob2 cbk1 in locus 14.7.16'!$O$42,'mob2 cbk1 in locus 14.7.16'!$O$46,'mob2 cbk1 in locus 14.7.16'!$O$50,'mob2 cbk1 in locus 14.7.16'!$O$54)</c:f>
                <c:numCache>
                  <c:formatCode>General</c:formatCode>
                  <c:ptCount val="4"/>
                  <c:pt idx="0">
                    <c:v>1.2055427546683417</c:v>
                  </c:pt>
                  <c:pt idx="1">
                    <c:v>0.72111025509279558</c:v>
                  </c:pt>
                  <c:pt idx="2">
                    <c:v>0.26666666666667049</c:v>
                  </c:pt>
                  <c:pt idx="3">
                    <c:v>0.2603416558635567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 cap="flat">
                <a:miter lim="800000"/>
              </a:ln>
            </c:spPr>
          </c:errBars>
          <c:cat>
            <c:strRef>
              <c:f>('mob2 cbk1 in locus 14.7.16'!$C$5,'mob2 cbk1 in locus 14.7.16'!$C$9,'mob2 cbk1 in locus 14.7.16'!$C$13,'mob2 cbk1 in locus 14.7.16'!$C$17)</c:f>
              <c:strCache>
                <c:ptCount val="4"/>
                <c:pt idx="0">
                  <c:v>Δku80</c:v>
                </c:pt>
                <c:pt idx="1">
                  <c:v>CBK1-mCherry</c:v>
                </c:pt>
                <c:pt idx="2">
                  <c:v>MOB2-GFP</c:v>
                </c:pt>
                <c:pt idx="3">
                  <c:v>MOB2-GFP + CBK1-mCherry</c:v>
                </c:pt>
              </c:strCache>
            </c:strRef>
          </c:cat>
          <c:val>
            <c:numRef>
              <c:f>('mob2 cbk1 in locus 14.7.16'!$M$42,'mob2 cbk1 in locus 14.7.16'!$M$46,'mob2 cbk1 in locus 14.7.16'!$M$50,'mob2 cbk1 in locus 14.7.16'!$M$54)</c:f>
              <c:numCache>
                <c:formatCode>General</c:formatCode>
                <c:ptCount val="4"/>
                <c:pt idx="0">
                  <c:v>123.7</c:v>
                </c:pt>
                <c:pt idx="1">
                  <c:v>110.60000000000001</c:v>
                </c:pt>
                <c:pt idx="2">
                  <c:v>118.13333333333333</c:v>
                </c:pt>
                <c:pt idx="3">
                  <c:v>108.56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E91-4DA5-AEE4-8416A58D78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7002496"/>
        <c:axId val="87024768"/>
      </c:barChart>
      <c:catAx>
        <c:axId val="87002496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87024768"/>
        <c:crosses val="autoZero"/>
        <c:auto val="1"/>
        <c:lblAlgn val="ctr"/>
        <c:lblOffset val="100"/>
        <c:noMultiLvlLbl val="0"/>
      </c:catAx>
      <c:valAx>
        <c:axId val="87024768"/>
        <c:scaling>
          <c:orientation val="minMax"/>
          <c:max val="130"/>
          <c:min val="0"/>
        </c:scaling>
        <c:delete val="0"/>
        <c:axPos val="l"/>
        <c:majorGridlines>
          <c:spPr>
            <a:ln w="12700">
              <a:solidFill>
                <a:schemeClr val="tx1"/>
              </a:solidFill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de-DE"/>
                  <a:t>conidia volume [fl]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8700249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DC305B-D344-444D-9568-68745DF13A2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804988" y="744538"/>
            <a:ext cx="31877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DDAA95-6386-469F-AB03-5CBBFCAF287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218423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EDDAA95-6386-469F-AB03-5CBBFCAF2879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24483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469" y="2486485"/>
            <a:ext cx="5830650" cy="171570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938" y="4535699"/>
            <a:ext cx="4801712" cy="204551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3201" y="320539"/>
            <a:ext cx="1543407" cy="6829488"/>
          </a:xfrm>
        </p:spPr>
        <p:txBody>
          <a:bodyPr vert="eaVert"/>
          <a:lstStyle/>
          <a:p>
            <a:r>
              <a:rPr lang="de-DE"/>
              <a:t>Titel durch Klicken hinzufüg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80" y="320539"/>
            <a:ext cx="4515895" cy="6829488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860" y="5143424"/>
            <a:ext cx="5830650" cy="158971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860" y="3392512"/>
            <a:ext cx="5830650" cy="1750912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80" y="1867642"/>
            <a:ext cx="3029651" cy="528238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957" y="1867642"/>
            <a:ext cx="3029651" cy="528238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79" y="1791678"/>
            <a:ext cx="3030843" cy="74668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79" y="2538363"/>
            <a:ext cx="3030843" cy="461166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4577" y="1791678"/>
            <a:ext cx="3032033" cy="74668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4577" y="2538363"/>
            <a:ext cx="3032033" cy="461166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81" y="318686"/>
            <a:ext cx="2256757" cy="135626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908" y="318687"/>
            <a:ext cx="3834700" cy="683134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81" y="1674949"/>
            <a:ext cx="2256757" cy="54750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527" y="5602924"/>
            <a:ext cx="4115753" cy="66145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527" y="715190"/>
            <a:ext cx="4115753" cy="480250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527" y="6264379"/>
            <a:ext cx="4115753" cy="9393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80" y="320538"/>
            <a:ext cx="6173629" cy="13340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80" y="1867642"/>
            <a:ext cx="6173629" cy="528238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79" y="7418685"/>
            <a:ext cx="1600571" cy="42614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693" y="7418685"/>
            <a:ext cx="2172203" cy="42614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6038" y="7418685"/>
            <a:ext cx="1600571" cy="42614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3.jpeg"/><Relationship Id="rId12" Type="http://schemas.microsoft.com/office/2007/relationships/hdphoto" Target="../media/hdphoto5.wdp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2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image" Target="../media/image5.jpeg"/><Relationship Id="rId5" Type="http://schemas.openxmlformats.org/officeDocument/2006/relationships/image" Target="../media/image2.jpeg"/><Relationship Id="rId15" Type="http://schemas.openxmlformats.org/officeDocument/2006/relationships/chart" Target="../charts/chart1.xml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jpeg"/><Relationship Id="rId14" Type="http://schemas.microsoft.com/office/2007/relationships/hdphoto" Target="../media/hdphoto6.wdp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1" name="Picture 7" descr="D:\Johannes\_Mob2 vir88 _ 5971\Infektionen\2016-2-25 infektion cbk1mcherry mob2gfp\3 dpi\6718\2-1\Image7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813" t="35044" r="3741" b="22511"/>
          <a:stretch/>
        </p:blipFill>
        <p:spPr bwMode="auto">
          <a:xfrm>
            <a:off x="3464501" y="178120"/>
            <a:ext cx="1656000" cy="165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D:\Johannes\_Mob2 vir88 _ 5971\Infektionen\2016-2-25 infektion cbk1mcherry mob2gfp\3 dpi\6720\Image9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993" t="46157" r="12561" b="11397"/>
          <a:stretch/>
        </p:blipFill>
        <p:spPr bwMode="auto">
          <a:xfrm rot="10800000">
            <a:off x="5185778" y="178120"/>
            <a:ext cx="1656000" cy="165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9" name="Textfeld 38"/>
          <p:cNvSpPr txBox="1"/>
          <p:nvPr/>
        </p:nvSpPr>
        <p:spPr>
          <a:xfrm>
            <a:off x="5185778" y="1811650"/>
            <a:ext cx="1656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MOB2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 + CBK1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mCherry</a:t>
            </a:r>
          </a:p>
        </p:txBody>
      </p:sp>
      <p:sp>
        <p:nvSpPr>
          <p:cNvPr id="40" name="Textfeld 39"/>
          <p:cNvSpPr txBox="1"/>
          <p:nvPr/>
        </p:nvSpPr>
        <p:spPr>
          <a:xfrm>
            <a:off x="3464501" y="1811650"/>
            <a:ext cx="165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MOB2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</a:p>
        </p:txBody>
      </p:sp>
      <p:sp>
        <p:nvSpPr>
          <p:cNvPr id="47" name="Textfeld 46"/>
          <p:cNvSpPr txBox="1"/>
          <p:nvPr/>
        </p:nvSpPr>
        <p:spPr>
          <a:xfrm>
            <a:off x="-69338" y="-76506"/>
            <a:ext cx="2952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>
                <a:latin typeface="Arial"/>
                <a:cs typeface="Arial"/>
              </a:rPr>
              <a:t>A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596899" y="6564758"/>
            <a:ext cx="7163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/>
                <a:cs typeface="Arial"/>
              </a:rPr>
              <a:t>parental </a:t>
            </a:r>
            <a:r>
              <a:rPr lang="de-DE" sz="800" dirty="0" err="1">
                <a:latin typeface="Arial"/>
                <a:cs typeface="Arial"/>
              </a:rPr>
              <a:t>strain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1241659" y="6564758"/>
            <a:ext cx="6617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i="1" dirty="0">
                <a:latin typeface="Arial" panose="020B0604020202020204" pitchFamily="34" charset="0"/>
                <a:cs typeface="Arial" panose="020B0604020202020204" pitchFamily="34" charset="0"/>
              </a:rPr>
              <a:t>CBK1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-mCherry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2433835" y="6564758"/>
            <a:ext cx="7624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i="1" dirty="0">
                <a:latin typeface="Arial" panose="020B0604020202020204" pitchFamily="34" charset="0"/>
                <a:cs typeface="Arial" panose="020B0604020202020204" pitchFamily="34" charset="0"/>
              </a:rPr>
              <a:t>MOB2-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r>
              <a:rPr lang="de-DE" sz="800" i="1" dirty="0">
                <a:latin typeface="Arial" panose="020B0604020202020204" pitchFamily="34" charset="0"/>
                <a:cs typeface="Arial" panose="020B0604020202020204" pitchFamily="34" charset="0"/>
              </a:rPr>
              <a:t> + CBK1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-mCherry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1922797" y="6564758"/>
            <a:ext cx="5437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i="1" dirty="0">
                <a:latin typeface="Arial" panose="020B0604020202020204" pitchFamily="34" charset="0"/>
                <a:cs typeface="Arial" panose="020B0604020202020204" pitchFamily="34" charset="0"/>
              </a:rPr>
              <a:t>MOB2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4055961" y="6564757"/>
            <a:ext cx="7163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/>
                <a:cs typeface="Arial"/>
              </a:rPr>
              <a:t>parental </a:t>
            </a:r>
            <a:r>
              <a:rPr lang="de-DE" sz="800" dirty="0" err="1">
                <a:latin typeface="Arial"/>
                <a:cs typeface="Arial"/>
              </a:rPr>
              <a:t>strain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4701658" y="6564757"/>
            <a:ext cx="6617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i="1" dirty="0">
                <a:latin typeface="Arial" panose="020B0604020202020204" pitchFamily="34" charset="0"/>
                <a:cs typeface="Arial" panose="020B0604020202020204" pitchFamily="34" charset="0"/>
              </a:rPr>
              <a:t>CBK1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-mCherry</a:t>
            </a:r>
          </a:p>
        </p:txBody>
      </p:sp>
      <p:sp>
        <p:nvSpPr>
          <p:cNvPr id="27" name="Textfeld 26"/>
          <p:cNvSpPr txBox="1"/>
          <p:nvPr/>
        </p:nvSpPr>
        <p:spPr>
          <a:xfrm>
            <a:off x="5874450" y="6564757"/>
            <a:ext cx="7624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i="1" dirty="0">
                <a:latin typeface="Arial" panose="020B0604020202020204" pitchFamily="34" charset="0"/>
                <a:cs typeface="Arial" panose="020B0604020202020204" pitchFamily="34" charset="0"/>
              </a:rPr>
              <a:t>MOB2-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r>
              <a:rPr lang="de-DE" sz="800" i="1" dirty="0">
                <a:latin typeface="Arial" panose="020B0604020202020204" pitchFamily="34" charset="0"/>
                <a:cs typeface="Arial" panose="020B0604020202020204" pitchFamily="34" charset="0"/>
              </a:rPr>
              <a:t> + CBK1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-mCherry</a:t>
            </a:r>
          </a:p>
        </p:txBody>
      </p:sp>
      <p:sp>
        <p:nvSpPr>
          <p:cNvPr id="28" name="Textfeld 27"/>
          <p:cNvSpPr txBox="1"/>
          <p:nvPr/>
        </p:nvSpPr>
        <p:spPr>
          <a:xfrm>
            <a:off x="5365228" y="6564757"/>
            <a:ext cx="5437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i="1" dirty="0">
                <a:latin typeface="Arial" panose="020B0604020202020204" pitchFamily="34" charset="0"/>
                <a:cs typeface="Arial" panose="020B0604020202020204" pitchFamily="34" charset="0"/>
              </a:rPr>
              <a:t>MOB2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</a:p>
        </p:txBody>
      </p:sp>
      <p:sp>
        <p:nvSpPr>
          <p:cNvPr id="30" name="Textfeld 29"/>
          <p:cNvSpPr txBox="1"/>
          <p:nvPr/>
        </p:nvSpPr>
        <p:spPr>
          <a:xfrm>
            <a:off x="4895858" y="512311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1" name="Textfeld 30"/>
          <p:cNvSpPr txBox="1"/>
          <p:nvPr/>
        </p:nvSpPr>
        <p:spPr>
          <a:xfrm>
            <a:off x="6135362" y="5153954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8" name="Textfeld 47"/>
          <p:cNvSpPr txBox="1"/>
          <p:nvPr/>
        </p:nvSpPr>
        <p:spPr>
          <a:xfrm>
            <a:off x="-69338" y="4807465"/>
            <a:ext cx="2952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>
                <a:latin typeface="Arial"/>
                <a:cs typeface="Arial"/>
              </a:rPr>
              <a:t>C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-69338" y="2256850"/>
            <a:ext cx="2952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>
                <a:latin typeface="Arial"/>
                <a:cs typeface="Arial"/>
              </a:rPr>
              <a:t>B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4" name="Gruppieren 53"/>
          <p:cNvGrpSpPr/>
          <p:nvPr/>
        </p:nvGrpSpPr>
        <p:grpSpPr>
          <a:xfrm>
            <a:off x="3604967" y="2332794"/>
            <a:ext cx="3096344" cy="2429581"/>
            <a:chOff x="3167783" y="2332794"/>
            <a:chExt cx="3096344" cy="2429581"/>
          </a:xfrm>
        </p:grpSpPr>
        <p:pic>
          <p:nvPicPr>
            <p:cNvPr id="1026" name="Picture 2" descr="D:\Johannes\_Mob2 vir88 _ 5971\Wachstum\2016-7-17 growth assay mob2_cbk1-Inlocus\5 tage\DSC_7329_gedreht.jpg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890" t="34351" r="52351" b="18297"/>
            <a:stretch/>
          </p:blipFill>
          <p:spPr bwMode="auto">
            <a:xfrm>
              <a:off x="3746252" y="2646696"/>
              <a:ext cx="1800000" cy="180000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3" name="Textfeld 42"/>
            <p:cNvSpPr txBox="1"/>
            <p:nvPr/>
          </p:nvSpPr>
          <p:spPr>
            <a:xfrm>
              <a:off x="4369230" y="4423821"/>
              <a:ext cx="71633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dirty="0">
                  <a:latin typeface="Arial"/>
                  <a:cs typeface="Arial"/>
                </a:rPr>
                <a:t>parental </a:t>
              </a:r>
              <a:r>
                <a:rPr lang="de-DE" sz="800" dirty="0" err="1">
                  <a:latin typeface="Arial"/>
                  <a:cs typeface="Arial"/>
                </a:rPr>
                <a:t>strain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feld 43"/>
            <p:cNvSpPr txBox="1"/>
            <p:nvPr/>
          </p:nvSpPr>
          <p:spPr>
            <a:xfrm>
              <a:off x="3167783" y="3328612"/>
              <a:ext cx="61572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CBK1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-mCherry</a:t>
              </a:r>
            </a:p>
          </p:txBody>
        </p:sp>
        <p:sp>
          <p:nvSpPr>
            <p:cNvPr id="45" name="Textfeld 44"/>
            <p:cNvSpPr txBox="1"/>
            <p:nvPr/>
          </p:nvSpPr>
          <p:spPr>
            <a:xfrm>
              <a:off x="5501643" y="3292598"/>
              <a:ext cx="76248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OB2-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  <a:r>
                <a:rPr lang="de-DE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+ CBK1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-mCherry</a:t>
              </a:r>
            </a:p>
          </p:txBody>
        </p:sp>
        <p:sp>
          <p:nvSpPr>
            <p:cNvPr id="46" name="Textfeld 45"/>
            <p:cNvSpPr txBox="1"/>
            <p:nvPr/>
          </p:nvSpPr>
          <p:spPr>
            <a:xfrm>
              <a:off x="4435371" y="2332794"/>
              <a:ext cx="5437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OB2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-GFP</a:t>
              </a:r>
            </a:p>
          </p:txBody>
        </p:sp>
        <p:sp>
          <p:nvSpPr>
            <p:cNvPr id="53" name="Textfeld 52"/>
            <p:cNvSpPr txBox="1"/>
            <p:nvPr/>
          </p:nvSpPr>
          <p:spPr>
            <a:xfrm>
              <a:off x="3636527" y="2378961"/>
              <a:ext cx="3994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b="1" dirty="0">
                  <a:latin typeface="Arial"/>
                  <a:cs typeface="Arial"/>
                </a:rPr>
                <a:t>MM</a:t>
              </a:r>
              <a:endParaRPr lang="de-DE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9" name="Gruppieren 48"/>
          <p:cNvGrpSpPr/>
          <p:nvPr/>
        </p:nvGrpSpPr>
        <p:grpSpPr>
          <a:xfrm>
            <a:off x="162412" y="2332794"/>
            <a:ext cx="3096344" cy="2429581"/>
            <a:chOff x="87270" y="2332794"/>
            <a:chExt cx="3096344" cy="2429581"/>
          </a:xfrm>
        </p:grpSpPr>
        <p:sp>
          <p:nvSpPr>
            <p:cNvPr id="36" name="Textfeld 35"/>
            <p:cNvSpPr txBox="1"/>
            <p:nvPr/>
          </p:nvSpPr>
          <p:spPr>
            <a:xfrm>
              <a:off x="1210642" y="4423821"/>
              <a:ext cx="71633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dirty="0">
                  <a:latin typeface="Arial"/>
                  <a:cs typeface="Arial"/>
                </a:rPr>
                <a:t>parental </a:t>
              </a:r>
              <a:r>
                <a:rPr lang="de-DE" sz="800" dirty="0" err="1">
                  <a:latin typeface="Arial"/>
                  <a:cs typeface="Arial"/>
                </a:rPr>
                <a:t>strain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feld 36"/>
            <p:cNvSpPr txBox="1"/>
            <p:nvPr/>
          </p:nvSpPr>
          <p:spPr>
            <a:xfrm>
              <a:off x="87270" y="3409536"/>
              <a:ext cx="6082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CBK1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-mCherry</a:t>
              </a:r>
            </a:p>
          </p:txBody>
        </p:sp>
        <p:sp>
          <p:nvSpPr>
            <p:cNvPr id="38" name="Textfeld 37"/>
            <p:cNvSpPr txBox="1"/>
            <p:nvPr/>
          </p:nvSpPr>
          <p:spPr>
            <a:xfrm>
              <a:off x="2421130" y="3322215"/>
              <a:ext cx="76248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OB2-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  <a:r>
                <a:rPr lang="de-DE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+ CBK1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-mCherry</a:t>
              </a:r>
            </a:p>
          </p:txBody>
        </p:sp>
        <p:sp>
          <p:nvSpPr>
            <p:cNvPr id="41" name="Textfeld 40"/>
            <p:cNvSpPr txBox="1"/>
            <p:nvPr/>
          </p:nvSpPr>
          <p:spPr>
            <a:xfrm>
              <a:off x="1274393" y="2332794"/>
              <a:ext cx="5437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OB2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-GFP</a:t>
              </a:r>
            </a:p>
          </p:txBody>
        </p:sp>
        <p:sp>
          <p:nvSpPr>
            <p:cNvPr id="52" name="Textfeld 51"/>
            <p:cNvSpPr txBox="1"/>
            <p:nvPr/>
          </p:nvSpPr>
          <p:spPr>
            <a:xfrm>
              <a:off x="573429" y="2378961"/>
              <a:ext cx="4555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b="1" dirty="0">
                  <a:latin typeface="Arial"/>
                  <a:cs typeface="Arial"/>
                </a:rPr>
                <a:t>PDA</a:t>
              </a:r>
              <a:endParaRPr lang="de-DE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27" name="Picture 3" descr="D:\Johannes\_Mob2 vir88 _ 5971\Wachstum\2016-7-17 growth assay mob2_cbk1-Inlocus\4 tage\DSC_7227_gedreht.jpg"/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1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916" t="29050" r="12225" b="20316"/>
            <a:stretch/>
          </p:blipFill>
          <p:spPr bwMode="auto">
            <a:xfrm>
              <a:off x="668210" y="2647627"/>
              <a:ext cx="1800000" cy="17990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pic>
        <p:nvPicPr>
          <p:cNvPr id="1029" name="Picture 5" descr="D:\Johannes\_Mob2 vir88 _ 5971\Infektionen\2016-2-25 infektion cbk1mcherry mob2gfp\3 dpi\ku80\2-1\Image5.jpg"/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775" t="40605" r="39779" b="16949"/>
          <a:stretch/>
        </p:blipFill>
        <p:spPr bwMode="auto">
          <a:xfrm>
            <a:off x="21945" y="178120"/>
            <a:ext cx="1656000" cy="165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feld 2"/>
          <p:cNvSpPr txBox="1"/>
          <p:nvPr/>
        </p:nvSpPr>
        <p:spPr>
          <a:xfrm>
            <a:off x="353661" y="1811650"/>
            <a:ext cx="9925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>
                <a:latin typeface="Arial"/>
                <a:cs typeface="Arial"/>
              </a:rPr>
              <a:t>parental </a:t>
            </a:r>
            <a:r>
              <a:rPr lang="de-DE" sz="1000" dirty="0" err="1">
                <a:latin typeface="Arial"/>
                <a:cs typeface="Arial"/>
              </a:rPr>
              <a:t>strain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32" name="Picture 8" descr="D:\Johannes\_Mob2 vir88 _ 5971\Infektionen\2016-2-25 infektion cbk1mcherry mob2gfp\3 dpi\6409\2-1\Image8.jpg"/>
          <p:cNvPicPr>
            <a:picLocks noChangeAspect="1" noChangeArrowheads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021" t="36841" r="25533" b="20714"/>
          <a:stretch/>
        </p:blipFill>
        <p:spPr bwMode="auto">
          <a:xfrm>
            <a:off x="1743223" y="178120"/>
            <a:ext cx="1656000" cy="16560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2" name="Textfeld 41"/>
          <p:cNvSpPr txBox="1"/>
          <p:nvPr/>
        </p:nvSpPr>
        <p:spPr>
          <a:xfrm>
            <a:off x="1743223" y="1811649"/>
            <a:ext cx="165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CBK1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mCherry</a:t>
            </a:r>
          </a:p>
        </p:txBody>
      </p:sp>
      <p:cxnSp>
        <p:nvCxnSpPr>
          <p:cNvPr id="58" name="Gerade Verbindung 57"/>
          <p:cNvCxnSpPr/>
          <p:nvPr/>
        </p:nvCxnSpPr>
        <p:spPr>
          <a:xfrm>
            <a:off x="1522834" y="1796847"/>
            <a:ext cx="104400" cy="0"/>
          </a:xfrm>
          <a:prstGeom prst="line">
            <a:avLst/>
          </a:prstGeom>
          <a:ln w="254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Gerade Verbindung 62"/>
          <p:cNvCxnSpPr/>
          <p:nvPr/>
        </p:nvCxnSpPr>
        <p:spPr>
          <a:xfrm>
            <a:off x="3258756" y="1796847"/>
            <a:ext cx="104400" cy="0"/>
          </a:xfrm>
          <a:prstGeom prst="line">
            <a:avLst/>
          </a:prstGeom>
          <a:ln w="254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Gerade Verbindung 63"/>
          <p:cNvCxnSpPr/>
          <p:nvPr/>
        </p:nvCxnSpPr>
        <p:spPr>
          <a:xfrm>
            <a:off x="4980315" y="1796847"/>
            <a:ext cx="104400" cy="0"/>
          </a:xfrm>
          <a:prstGeom prst="line">
            <a:avLst/>
          </a:prstGeom>
          <a:ln w="254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Gerade Verbindung 64"/>
          <p:cNvCxnSpPr/>
          <p:nvPr/>
        </p:nvCxnSpPr>
        <p:spPr>
          <a:xfrm>
            <a:off x="6706163" y="1796847"/>
            <a:ext cx="104400" cy="0"/>
          </a:xfrm>
          <a:prstGeom prst="line">
            <a:avLst/>
          </a:prstGeom>
          <a:ln w="254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50" name="Diagramm 4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2119692"/>
              </p:ext>
            </p:extLst>
          </p:nvPr>
        </p:nvGraphicFramePr>
        <p:xfrm>
          <a:off x="235858" y="4940448"/>
          <a:ext cx="288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55" name="Diagramm 5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3529255"/>
              </p:ext>
            </p:extLst>
          </p:nvPr>
        </p:nvGraphicFramePr>
        <p:xfrm>
          <a:off x="3678836" y="4941718"/>
          <a:ext cx="288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</p:spTree>
    <p:extLst>
      <p:ext uri="{BB962C8B-B14F-4D97-AF65-F5344CB8AC3E}">
        <p14:creationId xmlns:p14="http://schemas.microsoft.com/office/powerpoint/2010/main" val="3100065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117426" y="59645"/>
            <a:ext cx="6624736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5: Figure </a:t>
            </a: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S4.pptx.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MOB2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GFP and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CBK1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mCherry in locus fusions are functional.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parental strain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ΔChku80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CY6021) and its derivatives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ΔChcbk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BK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mCherry (CY6409)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ΔChmob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MOB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GFP (CY6718) and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ΔChcbk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BK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mCherry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ΔChmob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MOB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GFP (CY6720) were tested for their growth and virulence phenotypes. (A) Typical microscopic images of trypan blue stained leaves 3 days after infection. Scale bars = 20 µm. (B) Vegetative growth on PDA and MM. (C) Average conidia titer (left) and volume (right) recovered from oatmeal plates after 8 days. The data of 3 separate plates is given. Error bars are represented as the standard error from three replicates. Significant differences based on t-tests (p&lt;0.05) are marked with asterisks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979953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2</Words>
  <Application>Microsoft Office PowerPoint</Application>
  <PresentationFormat>Benutzerdefiniert</PresentationFormat>
  <Paragraphs>32</Paragraphs>
  <Slides>2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5" baseType="lpstr">
      <vt:lpstr>Arial</vt:lpstr>
      <vt:lpstr>Calibri</vt:lpstr>
      <vt:lpstr>Larissa-Desig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ohannes</dc:creator>
  <cp:lastModifiedBy>johannes.schmidpeter@altmuehlnet.de</cp:lastModifiedBy>
  <cp:revision>76</cp:revision>
  <cp:lastPrinted>2016-06-22T11:09:40Z</cp:lastPrinted>
  <dcterms:created xsi:type="dcterms:W3CDTF">2016-01-13T09:32:30Z</dcterms:created>
  <dcterms:modified xsi:type="dcterms:W3CDTF">2017-01-10T10:32:49Z</dcterms:modified>
</cp:coreProperties>
</file>